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9144000" cy="6858000" type="screen4x3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2317" autoAdjust="0"/>
  </p:normalViewPr>
  <p:slideViewPr>
    <p:cSldViewPr snapToGrid="0">
      <p:cViewPr varScale="1">
        <p:scale>
          <a:sx n="115" d="100"/>
          <a:sy n="115" d="100"/>
        </p:scale>
        <p:origin x="1530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3C3CDD6-73A2-4005-910B-99963E260C6B}" type="datetimeFigureOut">
              <a:rPr kumimoji="1" lang="ja-JP" altLang="en-US" smtClean="0"/>
              <a:t>2022/12/1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9350" y="1233488"/>
            <a:ext cx="443706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748163"/>
            <a:ext cx="5388610" cy="388486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0C85E4-A728-45DF-B07E-B233BB8F6A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64853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en-US" altLang="ja-JP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20C85E4-A728-45DF-B07E-B233BB8F6AAD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84147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89DA5-B23B-4FE0-9507-B708BFEC37D5}" type="datetimeFigureOut">
              <a:rPr kumimoji="1" lang="ja-JP" altLang="en-US" smtClean="0"/>
              <a:t>2022/12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A65257-7F3A-45D8-8A96-283F2CE3A4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9221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89DA5-B23B-4FE0-9507-B708BFEC37D5}" type="datetimeFigureOut">
              <a:rPr kumimoji="1" lang="ja-JP" altLang="en-US" smtClean="0"/>
              <a:t>2022/12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A65257-7F3A-45D8-8A96-283F2CE3A4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37837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89DA5-B23B-4FE0-9507-B708BFEC37D5}" type="datetimeFigureOut">
              <a:rPr kumimoji="1" lang="ja-JP" altLang="en-US" smtClean="0"/>
              <a:t>2022/12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A65257-7F3A-45D8-8A96-283F2CE3A4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6847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89DA5-B23B-4FE0-9507-B708BFEC37D5}" type="datetimeFigureOut">
              <a:rPr kumimoji="1" lang="ja-JP" altLang="en-US" smtClean="0"/>
              <a:t>2022/12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A65257-7F3A-45D8-8A96-283F2CE3A4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10316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89DA5-B23B-4FE0-9507-B708BFEC37D5}" type="datetimeFigureOut">
              <a:rPr kumimoji="1" lang="ja-JP" altLang="en-US" smtClean="0"/>
              <a:t>2022/12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A65257-7F3A-45D8-8A96-283F2CE3A4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16285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89DA5-B23B-4FE0-9507-B708BFEC37D5}" type="datetimeFigureOut">
              <a:rPr kumimoji="1" lang="ja-JP" altLang="en-US" smtClean="0"/>
              <a:t>2022/12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A65257-7F3A-45D8-8A96-283F2CE3A4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65741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89DA5-B23B-4FE0-9507-B708BFEC37D5}" type="datetimeFigureOut">
              <a:rPr kumimoji="1" lang="ja-JP" altLang="en-US" smtClean="0"/>
              <a:t>2022/12/1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A65257-7F3A-45D8-8A96-283F2CE3A4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95191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89DA5-B23B-4FE0-9507-B708BFEC37D5}" type="datetimeFigureOut">
              <a:rPr kumimoji="1" lang="ja-JP" altLang="en-US" smtClean="0"/>
              <a:t>2022/12/1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A65257-7F3A-45D8-8A96-283F2CE3A4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74165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89DA5-B23B-4FE0-9507-B708BFEC37D5}" type="datetimeFigureOut">
              <a:rPr kumimoji="1" lang="ja-JP" altLang="en-US" smtClean="0"/>
              <a:t>2022/12/1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A65257-7F3A-45D8-8A96-283F2CE3A4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23159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89DA5-B23B-4FE0-9507-B708BFEC37D5}" type="datetimeFigureOut">
              <a:rPr kumimoji="1" lang="ja-JP" altLang="en-US" smtClean="0"/>
              <a:t>2022/12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A65257-7F3A-45D8-8A96-283F2CE3A4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37789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89DA5-B23B-4FE0-9507-B708BFEC37D5}" type="datetimeFigureOut">
              <a:rPr kumimoji="1" lang="ja-JP" altLang="en-US" smtClean="0"/>
              <a:t>2022/12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A65257-7F3A-45D8-8A96-283F2CE3A4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42028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289DA5-B23B-4FE0-9507-B708BFEC37D5}" type="datetimeFigureOut">
              <a:rPr kumimoji="1" lang="ja-JP" altLang="en-US" smtClean="0"/>
              <a:t>2022/12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A65257-7F3A-45D8-8A96-283F2CE3A4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14446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四角形: 角を丸くする 3">
            <a:extLst>
              <a:ext uri="{FF2B5EF4-FFF2-40B4-BE49-F238E27FC236}">
                <a16:creationId xmlns:a16="http://schemas.microsoft.com/office/drawing/2014/main" id="{07BC36EF-D6E5-436B-9AA6-48C1A996199E}"/>
              </a:ext>
            </a:extLst>
          </p:cNvPr>
          <p:cNvSpPr/>
          <p:nvPr/>
        </p:nvSpPr>
        <p:spPr>
          <a:xfrm>
            <a:off x="420703" y="561731"/>
            <a:ext cx="8307660" cy="2062386"/>
          </a:xfrm>
          <a:prstGeom prst="roundRect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2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kumimoji="1" lang="ja-JP" altLang="en-US" sz="2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2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kumimoji="1" lang="ja-JP" altLang="en-US" sz="2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2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n–small-non-squamous cell</a:t>
            </a:r>
            <a:r>
              <a:rPr kumimoji="1" lang="ja-JP" altLang="en-US" sz="2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2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ung</a:t>
            </a:r>
            <a:r>
              <a:rPr kumimoji="1" lang="ja-JP" altLang="en-US" sz="2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2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ncer</a:t>
            </a:r>
          </a:p>
          <a:p>
            <a:r>
              <a:rPr kumimoji="1" lang="ja-JP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・</a:t>
            </a:r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GFR activating mutations</a:t>
            </a:r>
          </a:p>
          <a:p>
            <a:r>
              <a:rPr kumimoji="1" lang="ja-JP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・</a:t>
            </a:r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inical stage IIIB, IIIC, or IV or postoperative recurrence</a:t>
            </a:r>
          </a:p>
          <a:p>
            <a:r>
              <a:rPr kumimoji="1" lang="ja-JP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・</a:t>
            </a:r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arboring EGFR activating mutations</a:t>
            </a:r>
          </a:p>
          <a:p>
            <a:pPr lvl="0"/>
            <a:r>
              <a:rPr kumimoji="1" lang="ja-JP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・</a:t>
            </a:r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rformance status (ECOG) of 0–2</a:t>
            </a:r>
            <a:endParaRPr kumimoji="1" lang="ja-JP" altLang="ja-JP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ja-JP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・</a:t>
            </a:r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ge </a:t>
            </a:r>
            <a:r>
              <a:rPr kumimoji="1" lang="ja-JP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≥</a:t>
            </a:r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20</a:t>
            </a:r>
          </a:p>
        </p:txBody>
      </p:sp>
      <p:sp>
        <p:nvSpPr>
          <p:cNvPr id="5" name="四角形: 角を丸くする 4">
            <a:extLst>
              <a:ext uri="{FF2B5EF4-FFF2-40B4-BE49-F238E27FC236}">
                <a16:creationId xmlns:a16="http://schemas.microsoft.com/office/drawing/2014/main" id="{EE52AD98-4C5D-494B-9127-1BBC32005796}"/>
              </a:ext>
            </a:extLst>
          </p:cNvPr>
          <p:cNvSpPr/>
          <p:nvPr/>
        </p:nvSpPr>
        <p:spPr>
          <a:xfrm>
            <a:off x="2215677" y="3005115"/>
            <a:ext cx="4340772" cy="483476"/>
          </a:xfrm>
          <a:prstGeom prst="roundRect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formed consent/enrollment</a:t>
            </a:r>
            <a:endParaRPr kumimoji="1" lang="en-US" altLang="ja-JP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四角形: 角を丸くする 5">
            <a:extLst>
              <a:ext uri="{FF2B5EF4-FFF2-40B4-BE49-F238E27FC236}">
                <a16:creationId xmlns:a16="http://schemas.microsoft.com/office/drawing/2014/main" id="{5C0B5400-F790-478F-9F2D-C5E111F9E906}"/>
              </a:ext>
            </a:extLst>
          </p:cNvPr>
          <p:cNvSpPr/>
          <p:nvPr/>
        </p:nvSpPr>
        <p:spPr>
          <a:xfrm>
            <a:off x="420703" y="3869589"/>
            <a:ext cx="8307661" cy="2855422"/>
          </a:xfrm>
          <a:prstGeom prst="roundRect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comitinib</a:t>
            </a:r>
            <a:r>
              <a:rPr kumimoji="1" lang="en-US" altLang="ja-JP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45 mg orally, once daily)</a:t>
            </a:r>
          </a:p>
          <a:p>
            <a:endParaRPr kumimoji="1" lang="en-US" altLang="ja-JP" sz="10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phylactic treatment for dermatologic adverse events</a:t>
            </a:r>
          </a:p>
          <a:p>
            <a:pPr lvl="0"/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)	Minocycline </a:t>
            </a:r>
            <a:r>
              <a:rPr kumimoji="1" lang="en-US" altLang="ja-JP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100 mg orally, twice daily)</a:t>
            </a:r>
            <a:endParaRPr kumimoji="1" lang="ja-JP" altLang="ja-JP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0"/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)	Skin moisturizer containing heparinoid </a:t>
            </a:r>
            <a:r>
              <a:rPr kumimoji="1" lang="en-US" altLang="ja-JP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twice daily for face, neck, chest, back, and extremities)</a:t>
            </a:r>
            <a:endParaRPr kumimoji="1" lang="ja-JP" altLang="ja-JP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0"/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)	Medium topical steroid</a:t>
            </a:r>
            <a:r>
              <a:rPr kumimoji="1" lang="ja-JP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Class IV, twice daily for face)</a:t>
            </a:r>
            <a:endParaRPr kumimoji="1" lang="ja-JP" altLang="ja-JP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342900" lvl="0" indent="-342900">
              <a:buAutoNum type="arabicParenR" startAt="4"/>
            </a:pPr>
            <a:r>
              <a:rPr kumimoji="1" lang="ja-JP" alt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ery strong topical steroid </a:t>
            </a:r>
            <a:r>
              <a:rPr kumimoji="1" lang="en-US" altLang="ja-JP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Class II, twice daily for neck, chest, back, and extremities)</a:t>
            </a:r>
            <a:endParaRPr kumimoji="1" lang="ja-JP" altLang="ja-JP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0"/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)	Sunscreen </a:t>
            </a:r>
            <a:r>
              <a:rPr kumimoji="1" lang="en-US" altLang="ja-JP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sun protection factor ≥25, protection factor UVA 4-8 and UVA and UVB protection)</a:t>
            </a:r>
            <a:endParaRPr kumimoji="1" lang="ja-JP" altLang="ja-JP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矢印: 下 7">
            <a:extLst>
              <a:ext uri="{FF2B5EF4-FFF2-40B4-BE49-F238E27FC236}">
                <a16:creationId xmlns:a16="http://schemas.microsoft.com/office/drawing/2014/main" id="{72F602D5-82D9-475D-A903-9F27EB3D18A5}"/>
              </a:ext>
            </a:extLst>
          </p:cNvPr>
          <p:cNvSpPr/>
          <p:nvPr/>
        </p:nvSpPr>
        <p:spPr>
          <a:xfrm>
            <a:off x="4202134" y="2700311"/>
            <a:ext cx="378372" cy="241738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矢印: 下 8">
            <a:extLst>
              <a:ext uri="{FF2B5EF4-FFF2-40B4-BE49-F238E27FC236}">
                <a16:creationId xmlns:a16="http://schemas.microsoft.com/office/drawing/2014/main" id="{9CD9651E-C69A-4D6A-8607-FF8D6CF753FC}"/>
              </a:ext>
            </a:extLst>
          </p:cNvPr>
          <p:cNvSpPr/>
          <p:nvPr/>
        </p:nvSpPr>
        <p:spPr>
          <a:xfrm>
            <a:off x="4196880" y="3556904"/>
            <a:ext cx="378372" cy="241738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AC9069FF-09F5-4D34-87D2-2CB71C9D5D9D}"/>
              </a:ext>
            </a:extLst>
          </p:cNvPr>
          <p:cNvSpPr/>
          <p:nvPr/>
        </p:nvSpPr>
        <p:spPr>
          <a:xfrm>
            <a:off x="0" y="0"/>
            <a:ext cx="433965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l Figure 1. Study flow chart.</a:t>
            </a:r>
          </a:p>
        </p:txBody>
      </p:sp>
    </p:spTree>
    <p:extLst>
      <p:ext uri="{BB962C8B-B14F-4D97-AF65-F5344CB8AC3E}">
        <p14:creationId xmlns:p14="http://schemas.microsoft.com/office/powerpoint/2010/main" val="4743999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1</TotalTime>
  <Words>160</Words>
  <Application>Microsoft Office PowerPoint</Application>
  <PresentationFormat>画面に合わせる (4:3)</PresentationFormat>
  <Paragraphs>17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マサヒロ イワサク</dc:creator>
  <cp:lastModifiedBy>イワサク マサヒロ</cp:lastModifiedBy>
  <cp:revision>16</cp:revision>
  <cp:lastPrinted>2022-10-25T13:01:15Z</cp:lastPrinted>
  <dcterms:created xsi:type="dcterms:W3CDTF">2019-06-30T04:21:37Z</dcterms:created>
  <dcterms:modified xsi:type="dcterms:W3CDTF">2022-12-12T01:15:05Z</dcterms:modified>
</cp:coreProperties>
</file>